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7" r:id="rId2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150" d="100"/>
          <a:sy n="150" d="100"/>
        </p:scale>
        <p:origin x="-2344" y="10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BCC0F23-BA2A-422A-84A6-9A83BABE1220}" type="datetimeFigureOut">
              <a:rPr lang="en-US" smtClean="0"/>
              <a:t>7/18/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ADA5661-61B9-4E79-8B58-FCA78D08D2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171930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8"/>
            <a:ext cx="5143500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18B9F-0165-441C-A70A-947C7C25EEE5}" type="datetimeFigureOut">
              <a:rPr lang="en-US" smtClean="0"/>
              <a:t>7/18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2989D-96B6-4E73-807E-4838E4A3A4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50900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18B9F-0165-441C-A70A-947C7C25EEE5}" type="datetimeFigureOut">
              <a:rPr lang="en-US" smtClean="0"/>
              <a:t>7/18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2989D-96B6-4E73-807E-4838E4A3A4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13822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5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5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18B9F-0165-441C-A70A-947C7C25EEE5}" type="datetimeFigureOut">
              <a:rPr lang="en-US" smtClean="0"/>
              <a:t>7/18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2989D-96B6-4E73-807E-4838E4A3A4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57290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18B9F-0165-441C-A70A-947C7C25EEE5}" type="datetimeFigureOut">
              <a:rPr lang="en-US" smtClean="0"/>
              <a:t>7/18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2989D-96B6-4E73-807E-4838E4A3A4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66087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4"/>
            <a:ext cx="5915025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7"/>
            <a:ext cx="5915025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18B9F-0165-441C-A70A-947C7C25EEE5}" type="datetimeFigureOut">
              <a:rPr lang="en-US" smtClean="0"/>
              <a:t>7/18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2989D-96B6-4E73-807E-4838E4A3A4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46139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18B9F-0165-441C-A70A-947C7C25EEE5}" type="datetimeFigureOut">
              <a:rPr lang="en-US" smtClean="0"/>
              <a:t>7/18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2989D-96B6-4E73-807E-4838E4A3A4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28092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7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241552"/>
            <a:ext cx="2901255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2"/>
            <a:ext cx="2915543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18B9F-0165-441C-A70A-947C7C25EEE5}" type="datetimeFigureOut">
              <a:rPr lang="en-US" smtClean="0"/>
              <a:t>7/18/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2989D-96B6-4E73-807E-4838E4A3A4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45746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18B9F-0165-441C-A70A-947C7C25EEE5}" type="datetimeFigureOut">
              <a:rPr lang="en-US" smtClean="0"/>
              <a:t>7/18/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2989D-96B6-4E73-807E-4838E4A3A4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51288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18B9F-0165-441C-A70A-947C7C25EEE5}" type="datetimeFigureOut">
              <a:rPr lang="en-US" smtClean="0"/>
              <a:t>7/18/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2989D-96B6-4E73-807E-4838E4A3A4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45002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70"/>
            <a:ext cx="3471863" cy="64981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1"/>
            <a:ext cx="2211883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18B9F-0165-441C-A70A-947C7C25EEE5}" type="datetimeFigureOut">
              <a:rPr lang="en-US" smtClean="0"/>
              <a:t>7/18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2989D-96B6-4E73-807E-4838E4A3A4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49969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70"/>
            <a:ext cx="3471863" cy="6498167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1"/>
            <a:ext cx="2211883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18B9F-0165-441C-A70A-947C7C25EEE5}" type="datetimeFigureOut">
              <a:rPr lang="en-US" smtClean="0"/>
              <a:t>7/18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2989D-96B6-4E73-807E-4838E4A3A4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84756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7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7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618B9F-0165-441C-A70A-947C7C25EEE5}" type="datetimeFigureOut">
              <a:rPr lang="en-US" smtClean="0"/>
              <a:t>7/18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7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7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D2989D-96B6-4E73-807E-4838E4A3A4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3737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 preferRelativeResize="0"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2" y="1642533"/>
            <a:ext cx="5156200" cy="3130318"/>
          </a:xfrm>
          <a:prstGeom prst="rect">
            <a:avLst/>
          </a:prstGeom>
        </p:spPr>
      </p:pic>
      <p:cxnSp>
        <p:nvCxnSpPr>
          <p:cNvPr id="7" name="Straight Arrow Connector 6"/>
          <p:cNvCxnSpPr/>
          <p:nvPr/>
        </p:nvCxnSpPr>
        <p:spPr>
          <a:xfrm flipH="1">
            <a:off x="6036733" y="3716867"/>
            <a:ext cx="254000" cy="0"/>
          </a:xfrm>
          <a:prstGeom prst="straightConnector1">
            <a:avLst/>
          </a:prstGeom>
          <a:ln w="38100" cmpd="sng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6240101" y="3544527"/>
            <a:ext cx="5173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i="1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to</a:t>
            </a:r>
            <a:endParaRPr lang="en-US" sz="1400" b="1" i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869849" y="4910226"/>
            <a:ext cx="5086914" cy="127573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tabLst>
                <a:tab pos="933450" algn="l"/>
              </a:tabLst>
            </a:pPr>
            <a:r>
              <a:rPr lang="en-US" sz="1200" b="1" dirty="0" smtClean="0">
                <a:solidFill>
                  <a:srgbClr val="00000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Supplemental Figure S5.  The heirloom lines do not have the </a:t>
            </a:r>
            <a:r>
              <a:rPr lang="en-US" sz="1200" b="1" i="1" dirty="0" smtClean="0">
                <a:solidFill>
                  <a:srgbClr val="00000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Pto</a:t>
            </a:r>
            <a:r>
              <a:rPr lang="en-US" sz="1200" b="1" dirty="0" smtClean="0">
                <a:solidFill>
                  <a:srgbClr val="00000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gene. </a:t>
            </a:r>
            <a:r>
              <a:rPr lang="en-US" sz="1200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PCR products diagnostic for </a:t>
            </a:r>
            <a:r>
              <a:rPr lang="en-US" sz="1200" i="1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Pto</a:t>
            </a:r>
            <a:r>
              <a:rPr lang="en-US" sz="1200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 haplotypes were amplified </a:t>
            </a:r>
            <a:r>
              <a:rPr 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from </a:t>
            </a:r>
            <a:r>
              <a:rPr lang="en-US" sz="1200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genomic </a:t>
            </a:r>
            <a:r>
              <a:rPr 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DNA </a:t>
            </a:r>
            <a:r>
              <a:rPr lang="en-US" sz="1200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and </a:t>
            </a:r>
            <a:r>
              <a:rPr 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digested with </a:t>
            </a:r>
            <a:r>
              <a:rPr lang="en-US" sz="1200" dirty="0" err="1" smtClean="0">
                <a:ea typeface="Calibri" panose="020F0502020204030204" pitchFamily="34" charset="0"/>
                <a:cs typeface="Times New Roman" panose="02020603050405020304" pitchFamily="18" charset="0"/>
              </a:rPr>
              <a:t>FokI</a:t>
            </a:r>
            <a:r>
              <a:rPr lang="en-US" sz="1200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. The product at about 900 </a:t>
            </a:r>
            <a:r>
              <a:rPr lang="en-US" sz="1200" dirty="0" err="1" smtClean="0">
                <a:ea typeface="Calibri" panose="020F0502020204030204" pitchFamily="34" charset="0"/>
                <a:cs typeface="Times New Roman" panose="02020603050405020304" pitchFamily="18" charset="0"/>
              </a:rPr>
              <a:t>bp</a:t>
            </a:r>
            <a:r>
              <a:rPr lang="en-US" sz="1200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 (red arrow)  is diagnostic of the </a:t>
            </a:r>
            <a:r>
              <a:rPr lang="en-US" sz="1200" i="1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Pto</a:t>
            </a:r>
            <a:r>
              <a:rPr lang="en-US" sz="1200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 gene (present in RG-PtoR and Ontario 7710). The product at about 250 </a:t>
            </a:r>
            <a:r>
              <a:rPr lang="en-US" sz="1200" dirty="0" err="1" smtClean="0">
                <a:ea typeface="Calibri" panose="020F0502020204030204" pitchFamily="34" charset="0"/>
                <a:cs typeface="Times New Roman" panose="02020603050405020304" pitchFamily="18" charset="0"/>
              </a:rPr>
              <a:t>bp</a:t>
            </a:r>
            <a:r>
              <a:rPr lang="en-US" sz="1200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 (black arrow) is diagnostic of lines lacking </a:t>
            </a:r>
            <a:r>
              <a:rPr lang="en-US" sz="1200" i="1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Pto</a:t>
            </a:r>
            <a:r>
              <a:rPr lang="en-US" sz="1200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 (such as RG-PtoS and Moneymaker). None of the heirlooms appear to have the </a:t>
            </a:r>
            <a:r>
              <a:rPr lang="en-US" sz="1200" i="1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Pto</a:t>
            </a:r>
            <a:r>
              <a:rPr lang="en-US" sz="1200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 gene.</a:t>
            </a:r>
            <a:endParaRPr lang="en-US" sz="12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13" name="Straight Arrow Connector 12"/>
          <p:cNvCxnSpPr/>
          <p:nvPr/>
        </p:nvCxnSpPr>
        <p:spPr>
          <a:xfrm flipH="1">
            <a:off x="6019800" y="4131733"/>
            <a:ext cx="254000" cy="0"/>
          </a:xfrm>
          <a:prstGeom prst="straightConnector1">
            <a:avLst/>
          </a:prstGeom>
          <a:ln w="38100" cmpd="sng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8322000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1</TotalTime>
  <Words>95</Words>
  <Application>Microsoft Macintosh PowerPoint</Application>
  <PresentationFormat>Letter Paper (8.5x11 in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elu</dc:creator>
  <cp:lastModifiedBy>Greg Martin</cp:lastModifiedBy>
  <cp:revision>15</cp:revision>
  <dcterms:created xsi:type="dcterms:W3CDTF">2014-07-05T17:14:00Z</dcterms:created>
  <dcterms:modified xsi:type="dcterms:W3CDTF">2014-07-18T18:48:29Z</dcterms:modified>
</cp:coreProperties>
</file>